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slideLayouts/slideLayout19.xml" ContentType="application/vnd.openxmlformats-officedocument.presentationml.slideLayout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22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Masters/slideMaster2.xml" ContentType="application/vnd.openxmlformats-officedocument.presentationml.slideMaster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Default Extension="bin" ContentType="application/vnd.openxmlformats-officedocument.oleObject"/>
  <Override PartName="/ppt/notesSlides/notesSlide3.xml" ContentType="application/vnd.openxmlformats-officedocument.presentationml.notes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7"/>
  </p:notesMasterIdLst>
  <p:sldIdLst>
    <p:sldId id="267" r:id="rId3"/>
    <p:sldId id="260" r:id="rId4"/>
    <p:sldId id="261" r:id="rId5"/>
    <p:sldId id="284" r:id="rId6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7659" autoAdjust="0"/>
    <p:restoredTop sz="76178" autoAdjust="0"/>
  </p:normalViewPr>
  <p:slideViewPr>
    <p:cSldViewPr snapToGrid="0">
      <p:cViewPr varScale="1">
        <p:scale>
          <a:sx n="96" d="100"/>
          <a:sy n="96" d="100"/>
        </p:scale>
        <p:origin x="-96" y="-3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ableStyles" Target="tableStyles.xml"/><Relationship Id="rId5" Type="http://schemas.openxmlformats.org/officeDocument/2006/relationships/slide" Target="slides/slide3.xml"/><Relationship Id="rId10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wmf"/><Relationship Id="rId1" Type="http://schemas.openxmlformats.org/officeDocument/2006/relationships/image" Target="../media/image4.wmf"/><Relationship Id="rId5" Type="http://schemas.openxmlformats.org/officeDocument/2006/relationships/image" Target="../media/image8.emf"/><Relationship Id="rId4" Type="http://schemas.openxmlformats.org/officeDocument/2006/relationships/image" Target="../media/image7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image" Target="../media/image9.emf"/><Relationship Id="rId4" Type="http://schemas.openxmlformats.org/officeDocument/2006/relationships/image" Target="../media/image1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3DA14165-599A-4B56-8140-8F97AD3507AD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11F65739-BD6E-46E8-B058-5221AF14404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311939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FCB7DD0-AA0F-488D-B268-2104F47AF52C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6617742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31774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FCB7DD0-AA0F-488D-B268-2104F47AF52C}" type="slidenum">
              <a: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31774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38829386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5DBF722-6F47-4CEC-991E-7B1EA08C3DA4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9350330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47C93-CAFD-4F5D-9ADD-DE8B1FBB91F1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575D7-B7E8-407E-8119-A5A2E83911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15036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47C93-CAFD-4F5D-9ADD-DE8B1FBB91F1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575D7-B7E8-407E-8119-A5A2E83911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01241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47C93-CAFD-4F5D-9ADD-DE8B1FBB91F1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575D7-B7E8-407E-8119-A5A2E83911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138100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1BA14-C1DB-4B4B-8FC1-ACC8839E2D3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9E57C-A775-4918-825B-B07E7C2ED2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5136186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1BA14-C1DB-4B4B-8FC1-ACC8839E2D3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9E57C-A775-4918-825B-B07E7C2ED2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227431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1BA14-C1DB-4B4B-8FC1-ACC8839E2D3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9E57C-A775-4918-825B-B07E7C2ED2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9170557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1BA14-C1DB-4B4B-8FC1-ACC8839E2D3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9E57C-A775-4918-825B-B07E7C2ED2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7994123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1BA14-C1DB-4B4B-8FC1-ACC8839E2D3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9E57C-A775-4918-825B-B07E7C2ED2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9719136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1BA14-C1DB-4B4B-8FC1-ACC8839E2D3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9E57C-A775-4918-825B-B07E7C2ED2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4459153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1BA14-C1DB-4B4B-8FC1-ACC8839E2D3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9E57C-A775-4918-825B-B07E7C2ED2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0278599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1BA14-C1DB-4B4B-8FC1-ACC8839E2D3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9E57C-A775-4918-825B-B07E7C2ED2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9859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47C93-CAFD-4F5D-9ADD-DE8B1FBB91F1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575D7-B7E8-407E-8119-A5A2E83911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12803824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1BA14-C1DB-4B4B-8FC1-ACC8839E2D3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9E57C-A775-4918-825B-B07E7C2ED2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62433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1BA14-C1DB-4B4B-8FC1-ACC8839E2D3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9E57C-A775-4918-825B-B07E7C2ED2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5868610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1BA14-C1DB-4B4B-8FC1-ACC8839E2D3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9E57C-A775-4918-825B-B07E7C2ED2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39690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47C93-CAFD-4F5D-9ADD-DE8B1FBB91F1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575D7-B7E8-407E-8119-A5A2E83911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225656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47C93-CAFD-4F5D-9ADD-DE8B1FBB91F1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575D7-B7E8-407E-8119-A5A2E83911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6860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47C93-CAFD-4F5D-9ADD-DE8B1FBB91F1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575D7-B7E8-407E-8119-A5A2E83911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891898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47C93-CAFD-4F5D-9ADD-DE8B1FBB91F1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575D7-B7E8-407E-8119-A5A2E83911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35848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47C93-CAFD-4F5D-9ADD-DE8B1FBB91F1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575D7-B7E8-407E-8119-A5A2E83911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094555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47C93-CAFD-4F5D-9ADD-DE8B1FBB91F1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575D7-B7E8-407E-8119-A5A2E83911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736725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F47C93-CAFD-4F5D-9ADD-DE8B1FBB91F1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575D7-B7E8-407E-8119-A5A2E83911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14327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F47C93-CAFD-4F5D-9ADD-DE8B1FBB91F1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D575D7-B7E8-407E-8119-A5A2E83911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10338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A1BA14-C1DB-4B4B-8FC1-ACC8839E2D34}" type="datetimeFigureOut">
              <a:rPr lang="en-US" smtClean="0"/>
              <a:pPr/>
              <a:t>11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C9E57C-A775-4918-825B-B07E7C2ED2B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43591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3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5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4.bin"/><Relationship Id="rId5" Type="http://schemas.openxmlformats.org/officeDocument/2006/relationships/oleObject" Target="../embeddings/oleObject3.bin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5.png"/><Relationship Id="rId3" Type="http://schemas.openxmlformats.org/officeDocument/2006/relationships/notesSlide" Target="../notesSlides/notesSlide2.xml"/><Relationship Id="rId12" Type="http://schemas.openxmlformats.org/officeDocument/2006/relationships/oleObject" Target="../embeddings/oleObject8.bin"/><Relationship Id="rId2" Type="http://schemas.openxmlformats.org/officeDocument/2006/relationships/slideLayout" Target="../slideLayouts/slideLayout13.xml"/><Relationship Id="rId16" Type="http://schemas.openxmlformats.org/officeDocument/2006/relationships/oleObject" Target="../embeddings/oleObject9.bin"/><Relationship Id="rId1" Type="http://schemas.openxmlformats.org/officeDocument/2006/relationships/vmlDrawing" Target="../drawings/vmlDrawing2.vml"/><Relationship Id="rId6" Type="http://schemas.openxmlformats.org/officeDocument/2006/relationships/image" Target="../media/image13.png"/><Relationship Id="rId11" Type="http://schemas.microsoft.com/office/2007/relationships/hdphoto" Target="../media/hdphoto36.wdp"/><Relationship Id="rId5" Type="http://schemas.openxmlformats.org/officeDocument/2006/relationships/oleObject" Target="../embeddings/oleObject7.bin"/><Relationship Id="rId15" Type="http://schemas.microsoft.com/office/2007/relationships/hdphoto" Target="../media/hdphoto37.wdp"/><Relationship Id="rId10" Type="http://schemas.openxmlformats.org/officeDocument/2006/relationships/image" Target="../media/image14.png"/><Relationship Id="rId4" Type="http://schemas.openxmlformats.org/officeDocument/2006/relationships/oleObject" Target="../embeddings/oleObject6.bin"/><Relationship Id="rId9" Type="http://schemas.microsoft.com/office/2007/relationships/hdphoto" Target="../media/hdphoto35.wdp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40.wdp"/><Relationship Id="rId13" Type="http://schemas.openxmlformats.org/officeDocument/2006/relationships/image" Target="../media/image21.png"/><Relationship Id="rId18" Type="http://schemas.microsoft.com/office/2007/relationships/hdphoto" Target="../media/hdphoto45.wdp"/><Relationship Id="rId3" Type="http://schemas.openxmlformats.org/officeDocument/2006/relationships/image" Target="../media/image16.png"/><Relationship Id="rId7" Type="http://schemas.openxmlformats.org/officeDocument/2006/relationships/image" Target="../media/image18.png"/><Relationship Id="rId12" Type="http://schemas.microsoft.com/office/2007/relationships/hdphoto" Target="../media/hdphoto42.wdp"/><Relationship Id="rId17" Type="http://schemas.openxmlformats.org/officeDocument/2006/relationships/image" Target="../media/image23.png"/><Relationship Id="rId2" Type="http://schemas.openxmlformats.org/officeDocument/2006/relationships/notesSlide" Target="../notesSlides/notesSlide3.xml"/><Relationship Id="rId16" Type="http://schemas.microsoft.com/office/2007/relationships/hdphoto" Target="../media/hdphoto44.wdp"/><Relationship Id="rId1" Type="http://schemas.openxmlformats.org/officeDocument/2006/relationships/slideLayout" Target="../slideLayouts/slideLayout18.xml"/><Relationship Id="rId6" Type="http://schemas.microsoft.com/office/2007/relationships/hdphoto" Target="../media/hdphoto39.wdp"/><Relationship Id="rId11" Type="http://schemas.openxmlformats.org/officeDocument/2006/relationships/image" Target="../media/image20.png"/><Relationship Id="rId5" Type="http://schemas.openxmlformats.org/officeDocument/2006/relationships/image" Target="../media/image17.png"/><Relationship Id="rId15" Type="http://schemas.openxmlformats.org/officeDocument/2006/relationships/image" Target="../media/image22.png"/><Relationship Id="rId10" Type="http://schemas.microsoft.com/office/2007/relationships/hdphoto" Target="../media/hdphoto41.wdp"/><Relationship Id="rId4" Type="http://schemas.microsoft.com/office/2007/relationships/hdphoto" Target="../media/hdphoto38.wdp"/><Relationship Id="rId9" Type="http://schemas.openxmlformats.org/officeDocument/2006/relationships/image" Target="../media/image19.png"/><Relationship Id="rId14" Type="http://schemas.microsoft.com/office/2007/relationships/hdphoto" Target="../media/hdphoto4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659288" y="3739179"/>
            <a:ext cx="10725450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600" b="1" noProof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kumimoji="0" lang="en-US" sz="16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.  C</a:t>
            </a:r>
            <a:r>
              <a:rPr lang="en-US" sz="16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llaterals</a:t>
            </a:r>
            <a:r>
              <a:rPr lang="en-US" sz="1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nearing complete pruning (rarefaction) in 3xTg-AD mice.  A</a:t>
            </a: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kumimoji="0" lang="en-US" sz="1600" b="0" i="0" u="none" strike="noStrike" kern="120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fter perfusion (100 mmHg) with PBS containing Evans blue dye plus nitroprusside, followed by </a:t>
            </a:r>
            <a:r>
              <a:rPr lang="en-US" sz="16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crofil</a:t>
            </a:r>
            <a:r>
              <a:rPr lang="en-US" sz="1600" baseline="300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ith viscosity set to limit capillary transit.  Dye binds surface </a:t>
            </a:r>
            <a:r>
              <a:rPr lang="en-US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Cs </a:t>
            </a:r>
            <a:r>
              <a:rPr lang="en-US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aids identifying lumen if a </a:t>
            </a:r>
            <a:r>
              <a:rPr lang="en-US" sz="16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crofil</a:t>
            </a:r>
            <a:r>
              <a:rPr lang="en-US" sz="1600" baseline="300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ap 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ccurs.  Inset, </a:t>
            </a:r>
            <a:r>
              <a:rPr lang="en-US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e diameter of the center-most segment of a pial collateral has been reduced to approximately that of a capillary.  The Microfil ends at termini that are preceded by a small length containing dye, which confirms presence of a contiguous lumen connecting to the opposing arterioles.  </a:t>
            </a:r>
            <a:r>
              <a:rPr lang="en-US" sz="1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A second brain after the same filling protocol, followed by optical clearing (which removes the blue dye).  Inset, A tortuous collateral in the pia has narrowed to a pinpoint adjacent to a second collateral that it was presumably connected to previously.  </a:t>
            </a:r>
            <a:r>
              <a:rPr lang="en-US" sz="1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much more numerous distal-most arterioles that do not continue on as a collateral descend into the cortex as penetrating arterioles (evident in the non-inset images of A-C). 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laterals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connecting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CA, ACA and PCA tree are located in the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a,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none present within the cortical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enchyma.</a:t>
            </a:r>
            <a:r>
              <a:rPr lang="en-US" sz="16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3,26.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sence of collaterals that are almost completely pruned away is rare, since the process occurs gradually over many months.  </a:t>
            </a:r>
          </a:p>
        </p:txBody>
      </p:sp>
      <p:grpSp>
        <p:nvGrpSpPr>
          <p:cNvPr id="18" name="Group 17"/>
          <p:cNvGrpSpPr/>
          <p:nvPr/>
        </p:nvGrpSpPr>
        <p:grpSpPr>
          <a:xfrm>
            <a:off x="720753" y="480839"/>
            <a:ext cx="10663984" cy="3107913"/>
            <a:chOff x="720753" y="480839"/>
            <a:chExt cx="10663984" cy="3107913"/>
          </a:xfrm>
        </p:grpSpPr>
        <p:grpSp>
          <p:nvGrpSpPr>
            <p:cNvPr id="10" name="Group 9"/>
            <p:cNvGrpSpPr/>
            <p:nvPr/>
          </p:nvGrpSpPr>
          <p:grpSpPr>
            <a:xfrm>
              <a:off x="720753" y="517693"/>
              <a:ext cx="7615212" cy="3000004"/>
              <a:chOff x="1679764" y="195228"/>
              <a:chExt cx="8911026" cy="3779848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1722315" y="195228"/>
                <a:ext cx="8772007" cy="3779848"/>
                <a:chOff x="1722315" y="195228"/>
                <a:chExt cx="8772007" cy="3779848"/>
              </a:xfrm>
            </p:grpSpPr>
            <p:cxnSp>
              <p:nvCxnSpPr>
                <p:cNvPr id="5" name="Straight Arrow Connector 4"/>
                <p:cNvCxnSpPr/>
                <p:nvPr/>
              </p:nvCxnSpPr>
              <p:spPr>
                <a:xfrm flipH="1">
                  <a:off x="6510069" y="2400343"/>
                  <a:ext cx="293298" cy="396815"/>
                </a:xfrm>
                <a:prstGeom prst="straightConnector1">
                  <a:avLst/>
                </a:prstGeom>
                <a:ln w="57150"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8" name="Picture 7"/>
                <p:cNvPicPr>
                  <a:picLocks noChangeAspect="1"/>
                </p:cNvPicPr>
                <p:nvPr/>
              </p:nvPicPr>
              <p:blipFill>
                <a:blip r:embed="rId3" cstate="print"/>
                <a:stretch>
                  <a:fillRect/>
                </a:stretch>
              </p:blipFill>
              <p:spPr>
                <a:xfrm>
                  <a:off x="1722315" y="195228"/>
                  <a:ext cx="4320677" cy="3779848"/>
                </a:xfrm>
                <a:prstGeom prst="rect">
                  <a:avLst/>
                </a:prstGeom>
              </p:spPr>
            </p:pic>
            <p:pic>
              <p:nvPicPr>
                <p:cNvPr id="9" name="Picture 8"/>
                <p:cNvPicPr>
                  <a:picLocks noChangeAspect="1"/>
                </p:cNvPicPr>
                <p:nvPr/>
              </p:nvPicPr>
              <p:blipFill>
                <a:blip r:embed="rId4" cstate="print"/>
                <a:stretch>
                  <a:fillRect/>
                </a:stretch>
              </p:blipFill>
              <p:spPr>
                <a:xfrm>
                  <a:off x="6165787" y="195228"/>
                  <a:ext cx="4328535" cy="3779848"/>
                </a:xfrm>
                <a:prstGeom prst="rect">
                  <a:avLst/>
                </a:prstGeom>
              </p:spPr>
            </p:pic>
            <p:cxnSp>
              <p:nvCxnSpPr>
                <p:cNvPr id="12" name="Straight Arrow Connector 11"/>
                <p:cNvCxnSpPr/>
                <p:nvPr/>
              </p:nvCxnSpPr>
              <p:spPr>
                <a:xfrm>
                  <a:off x="4028663" y="1687588"/>
                  <a:ext cx="66261" cy="278296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" name="TextBox 2"/>
              <p:cNvSpPr txBox="1"/>
              <p:nvPr/>
            </p:nvSpPr>
            <p:spPr>
              <a:xfrm>
                <a:off x="1701205" y="3147241"/>
                <a:ext cx="1252941" cy="4265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>
                    <a:solidFill>
                      <a:schemeClr val="bg1"/>
                    </a:solidFill>
                    <a:sym typeface="Wingdings" panose="05000000000000000000" pitchFamily="2" charset="2"/>
                  </a:rPr>
                  <a:t> t</a:t>
                </a:r>
                <a:r>
                  <a:rPr lang="en-US" sz="1600" b="1" dirty="0" smtClean="0">
                    <a:solidFill>
                      <a:schemeClr val="bg1"/>
                    </a:solidFill>
                  </a:rPr>
                  <a:t>o MCA</a:t>
                </a:r>
                <a:endParaRPr lang="en-US" sz="16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>
                <a:off x="4719622" y="457191"/>
                <a:ext cx="1295109" cy="4265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>
                    <a:solidFill>
                      <a:schemeClr val="bg1"/>
                    </a:solidFill>
                  </a:rPr>
                  <a:t>to ACA   </a:t>
                </a:r>
                <a:r>
                  <a:rPr lang="en-US" sz="1600" b="1" dirty="0" smtClean="0">
                    <a:solidFill>
                      <a:schemeClr val="bg1"/>
                    </a:solidFill>
                    <a:sym typeface="Wingdings" panose="05000000000000000000" pitchFamily="2" charset="2"/>
                  </a:rPr>
                  <a:t></a:t>
                </a:r>
                <a:endParaRPr lang="en-US" sz="16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6128772" y="2777910"/>
                <a:ext cx="1252941" cy="4265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>
                    <a:solidFill>
                      <a:schemeClr val="bg1"/>
                    </a:solidFill>
                    <a:sym typeface="Wingdings" panose="05000000000000000000" pitchFamily="2" charset="2"/>
                  </a:rPr>
                  <a:t> t</a:t>
                </a:r>
                <a:r>
                  <a:rPr lang="en-US" sz="1600" b="1" dirty="0" smtClean="0">
                    <a:solidFill>
                      <a:schemeClr val="bg1"/>
                    </a:solidFill>
                  </a:rPr>
                  <a:t>o MCA</a:t>
                </a:r>
                <a:endParaRPr lang="en-US" sz="16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9404476" y="1688667"/>
                <a:ext cx="1186314" cy="4265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>
                    <a:solidFill>
                      <a:schemeClr val="bg1"/>
                    </a:solidFill>
                  </a:rPr>
                  <a:t>to ACA </a:t>
                </a:r>
                <a:r>
                  <a:rPr lang="en-US" sz="1600" b="1" dirty="0" smtClean="0">
                    <a:solidFill>
                      <a:schemeClr val="bg1"/>
                    </a:solidFill>
                    <a:sym typeface="Wingdings" panose="05000000000000000000" pitchFamily="2" charset="2"/>
                  </a:rPr>
                  <a:t></a:t>
                </a:r>
                <a:endParaRPr lang="en-US" sz="1600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1679764" y="3569971"/>
                <a:ext cx="3241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solidFill>
                      <a:schemeClr val="bg1"/>
                    </a:solidFill>
                  </a:rPr>
                  <a:t>A</a:t>
                </a:r>
                <a:endParaRPr lang="en-US" b="1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6111110" y="3547776"/>
                <a:ext cx="3145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 smtClean="0">
                    <a:solidFill>
                      <a:schemeClr val="bg1"/>
                    </a:solidFill>
                  </a:rPr>
                  <a:t>B</a:t>
                </a:r>
                <a:endParaRPr lang="en-US" b="1" dirty="0">
                  <a:solidFill>
                    <a:schemeClr val="bg1"/>
                  </a:solidFill>
                </a:endParaRPr>
              </a:p>
            </p:txBody>
          </p:sp>
        </p:grpSp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8354849" y="500251"/>
              <a:ext cx="3029888" cy="3029888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8316429" y="3219420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chemeClr val="bg1"/>
                  </a:solidFill>
                </a:rPr>
                <a:t>C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8321058" y="480839"/>
              <a:ext cx="18936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solidFill>
                    <a:schemeClr val="bg1"/>
                  </a:solidFill>
                </a:rPr>
                <a:t>Intravascular FITC-</a:t>
              </a:r>
              <a:r>
                <a:rPr lang="en-US" sz="1200" b="1" dirty="0" err="1" smtClean="0">
                  <a:solidFill>
                    <a:schemeClr val="bg1"/>
                  </a:solidFill>
                </a:rPr>
                <a:t>isolectin</a:t>
              </a:r>
              <a:endParaRPr lang="en-US" sz="1200" b="1" dirty="0">
                <a:solidFill>
                  <a:schemeClr val="bg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xmlns="" val="38599014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310374" y="268289"/>
            <a:ext cx="7605221" cy="5232399"/>
            <a:chOff x="2218014" y="268289"/>
            <a:chExt cx="7605221" cy="5232399"/>
          </a:xfrm>
        </p:grpSpPr>
        <p:grpSp>
          <p:nvGrpSpPr>
            <p:cNvPr id="12" name="Group 11"/>
            <p:cNvGrpSpPr/>
            <p:nvPr/>
          </p:nvGrpSpPr>
          <p:grpSpPr>
            <a:xfrm>
              <a:off x="2226978" y="268289"/>
              <a:ext cx="3582987" cy="2855911"/>
              <a:chOff x="1898362" y="525473"/>
              <a:chExt cx="3582987" cy="2855911"/>
            </a:xfrm>
          </p:grpSpPr>
          <p:grpSp>
            <p:nvGrpSpPr>
              <p:cNvPr id="13" name="Group 12"/>
              <p:cNvGrpSpPr/>
              <p:nvPr/>
            </p:nvGrpSpPr>
            <p:grpSpPr>
              <a:xfrm>
                <a:off x="1898362" y="525473"/>
                <a:ext cx="3582987" cy="2855911"/>
                <a:chOff x="2340352" y="4476059"/>
                <a:chExt cx="2936725" cy="2213279"/>
              </a:xfrm>
            </p:grpSpPr>
            <p:grpSp>
              <p:nvGrpSpPr>
                <p:cNvPr id="15" name="Group 14"/>
                <p:cNvGrpSpPr/>
                <p:nvPr/>
              </p:nvGrpSpPr>
              <p:grpSpPr>
                <a:xfrm>
                  <a:off x="2340352" y="4478519"/>
                  <a:ext cx="1523661" cy="2210819"/>
                  <a:chOff x="681004" y="605202"/>
                  <a:chExt cx="1523661" cy="2210819"/>
                </a:xfrm>
              </p:grpSpPr>
              <p:graphicFrame>
                <p:nvGraphicFramePr>
                  <p:cNvPr id="19" name="Object 18"/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xmlns="" val="578144561"/>
                      </p:ext>
                    </p:extLst>
                  </p:nvPr>
                </p:nvGraphicFramePr>
                <p:xfrm>
                  <a:off x="681004" y="605202"/>
                  <a:ext cx="1523661" cy="2210819"/>
                </p:xfrm>
                <a:graphic>
                  <a:graphicData uri="http://schemas.openxmlformats.org/presentationml/2006/ole">
                    <p:oleObj spid="_x0000_s5947" name="Prism Project" r:id="rId3" imgW="2011680" imgH="2907720" progId="">
                      <p:embed/>
                    </p:oleObj>
                  </a:graphicData>
                </a:graphic>
              </p:graphicFrame>
              <p:sp>
                <p:nvSpPr>
                  <p:cNvPr id="20" name="TextBox 19"/>
                  <p:cNvSpPr txBox="1"/>
                  <p:nvPr/>
                </p:nvSpPr>
                <p:spPr>
                  <a:xfrm>
                    <a:off x="1686575" y="1458719"/>
                    <a:ext cx="220812" cy="2828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240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rPr>
                      <a:t>*</a:t>
                    </a:r>
                    <a:endParaRPr kumimoji="0" lang="en-US" sz="24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endParaRPr>
                  </a:p>
                </p:txBody>
              </p:sp>
            </p:grpSp>
            <p:grpSp>
              <p:nvGrpSpPr>
                <p:cNvPr id="16" name="Group 15"/>
                <p:cNvGrpSpPr/>
                <p:nvPr/>
              </p:nvGrpSpPr>
              <p:grpSpPr>
                <a:xfrm>
                  <a:off x="3763825" y="4476059"/>
                  <a:ext cx="1513252" cy="2212050"/>
                  <a:chOff x="2170808" y="1327498"/>
                  <a:chExt cx="1513252" cy="2212050"/>
                </a:xfrm>
              </p:grpSpPr>
              <p:graphicFrame>
                <p:nvGraphicFramePr>
                  <p:cNvPr id="17" name="Object 16"/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xmlns="" val="3981617319"/>
                      </p:ext>
                    </p:extLst>
                  </p:nvPr>
                </p:nvGraphicFramePr>
                <p:xfrm>
                  <a:off x="2170808" y="1327498"/>
                  <a:ext cx="1513252" cy="2212050"/>
                </p:xfrm>
                <a:graphic>
                  <a:graphicData uri="http://schemas.openxmlformats.org/presentationml/2006/ole">
                    <p:oleObj spid="_x0000_s5948" name="Prism Project" r:id="rId4" imgW="1993320" imgH="2907720" progId="">
                      <p:embed/>
                    </p:oleObj>
                  </a:graphicData>
                </a:graphic>
              </p:graphicFrame>
              <p:sp>
                <p:nvSpPr>
                  <p:cNvPr id="18" name="TextBox 17"/>
                  <p:cNvSpPr txBox="1"/>
                  <p:nvPr/>
                </p:nvSpPr>
                <p:spPr>
                  <a:xfrm>
                    <a:off x="3235378" y="1997384"/>
                    <a:ext cx="220812" cy="2828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240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rPr>
                      <a:t>*</a:t>
                    </a:r>
                    <a:endParaRPr kumimoji="0" lang="en-US" sz="24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endParaRPr>
                  </a:p>
                </p:txBody>
              </p:sp>
            </p:grpSp>
          </p:grpSp>
          <p:sp>
            <p:nvSpPr>
              <p:cNvPr id="14" name="TextBox 13"/>
              <p:cNvSpPr txBox="1"/>
              <p:nvPr/>
            </p:nvSpPr>
            <p:spPr>
              <a:xfrm>
                <a:off x="1984362" y="838205"/>
                <a:ext cx="3241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8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A</a:t>
                </a:r>
              </a:p>
            </p:txBody>
          </p:sp>
        </p:grpSp>
        <p:grpSp>
          <p:nvGrpSpPr>
            <p:cNvPr id="37" name="Group 36"/>
            <p:cNvGrpSpPr/>
            <p:nvPr/>
          </p:nvGrpSpPr>
          <p:grpSpPr>
            <a:xfrm>
              <a:off x="2218014" y="2851150"/>
              <a:ext cx="3511282" cy="2649538"/>
              <a:chOff x="1560784" y="3051181"/>
              <a:chExt cx="3511282" cy="2649538"/>
            </a:xfrm>
          </p:grpSpPr>
          <p:grpSp>
            <p:nvGrpSpPr>
              <p:cNvPr id="23" name="Group 22"/>
              <p:cNvGrpSpPr/>
              <p:nvPr/>
            </p:nvGrpSpPr>
            <p:grpSpPr>
              <a:xfrm>
                <a:off x="1560784" y="3051181"/>
                <a:ext cx="3436662" cy="2649538"/>
                <a:chOff x="5971101" y="2081635"/>
                <a:chExt cx="2997558" cy="2282426"/>
              </a:xfrm>
            </p:grpSpPr>
            <p:graphicFrame>
              <p:nvGraphicFramePr>
                <p:cNvPr id="24" name="Object 23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xmlns="" val="464266394"/>
                    </p:ext>
                  </p:extLst>
                </p:nvPr>
              </p:nvGraphicFramePr>
              <p:xfrm>
                <a:off x="6085788" y="2081635"/>
                <a:ext cx="2882871" cy="2282426"/>
              </p:xfrm>
              <a:graphic>
                <a:graphicData uri="http://schemas.openxmlformats.org/presentationml/2006/ole">
                  <p:oleObj spid="_x0000_s5949" name="Prism Project" r:id="rId5" imgW="3672000" imgH="2916000" progId="">
                    <p:embed/>
                  </p:oleObj>
                </a:graphicData>
              </a:graphic>
            </p:graphicFrame>
            <p:grpSp>
              <p:nvGrpSpPr>
                <p:cNvPr id="25" name="Group 24"/>
                <p:cNvGrpSpPr/>
                <p:nvPr/>
              </p:nvGrpSpPr>
              <p:grpSpPr>
                <a:xfrm>
                  <a:off x="5971101" y="2089626"/>
                  <a:ext cx="2494155" cy="1065303"/>
                  <a:chOff x="5971101" y="475123"/>
                  <a:chExt cx="2494155" cy="1065303"/>
                </a:xfrm>
              </p:grpSpPr>
              <p:sp>
                <p:nvSpPr>
                  <p:cNvPr id="26" name="TextBox 25"/>
                  <p:cNvSpPr txBox="1"/>
                  <p:nvPr/>
                </p:nvSpPr>
                <p:spPr>
                  <a:xfrm>
                    <a:off x="8236742" y="1142728"/>
                    <a:ext cx="228514" cy="39769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240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rPr>
                      <a:t>*</a:t>
                    </a:r>
                    <a:endParaRPr kumimoji="0" lang="en-US" sz="24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endParaRPr>
                  </a:p>
                </p:txBody>
              </p:sp>
              <p:sp>
                <p:nvSpPr>
                  <p:cNvPr id="27" name="TextBox 26"/>
                  <p:cNvSpPr txBox="1"/>
                  <p:nvPr/>
                </p:nvSpPr>
                <p:spPr>
                  <a:xfrm>
                    <a:off x="5971101" y="475123"/>
                    <a:ext cx="314510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800" b="1" i="0" u="none" strike="noStrike" kern="0" cap="none" spc="0" normalizeH="0" baseline="0" noProof="0" dirty="0" smtClean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rPr>
                      <a:t>B</a:t>
                    </a:r>
                  </a:p>
                </p:txBody>
              </p:sp>
            </p:grpSp>
          </p:grpSp>
          <p:sp>
            <p:nvSpPr>
              <p:cNvPr id="32" name="TextBox 31"/>
              <p:cNvSpPr txBox="1"/>
              <p:nvPr/>
            </p:nvSpPr>
            <p:spPr>
              <a:xfrm>
                <a:off x="2609511" y="5276116"/>
                <a:ext cx="246255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8 </a:t>
                </a:r>
                <a:r>
                  <a:rPr kumimoji="0" lang="en-US" sz="1400" b="1" i="0" u="none" strike="noStrike" kern="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mos</a:t>
                </a:r>
                <a:r>
                  <a:rPr kumimoji="0" lang="en-US" sz="14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WT            8 </a:t>
                </a:r>
                <a:r>
                  <a:rPr kumimoji="0" lang="en-US" sz="1400" b="1" i="0" u="none" strike="noStrike" kern="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mos</a:t>
                </a:r>
                <a:r>
                  <a:rPr kumimoji="0" lang="en-US" sz="14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3xTg</a:t>
                </a:r>
                <a:endParaRPr kumimoji="0" lang="en-US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p:grpSp>
        <p:grpSp>
          <p:nvGrpSpPr>
            <p:cNvPr id="38" name="Group 37"/>
            <p:cNvGrpSpPr/>
            <p:nvPr/>
          </p:nvGrpSpPr>
          <p:grpSpPr>
            <a:xfrm>
              <a:off x="6124290" y="2784475"/>
              <a:ext cx="3698945" cy="2601137"/>
              <a:chOff x="5413911" y="2982752"/>
              <a:chExt cx="3698945" cy="2601137"/>
            </a:xfrm>
          </p:grpSpPr>
          <p:grpSp>
            <p:nvGrpSpPr>
              <p:cNvPr id="28" name="Group 27"/>
              <p:cNvGrpSpPr/>
              <p:nvPr/>
            </p:nvGrpSpPr>
            <p:grpSpPr>
              <a:xfrm>
                <a:off x="5413911" y="2982752"/>
                <a:ext cx="3656013" cy="2587625"/>
                <a:chOff x="487599" y="1887997"/>
                <a:chExt cx="3656013" cy="2587625"/>
              </a:xfrm>
            </p:grpSpPr>
            <p:graphicFrame>
              <p:nvGraphicFramePr>
                <p:cNvPr id="29" name="Object 28"/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xmlns="" val="1637652779"/>
                    </p:ext>
                  </p:extLst>
                </p:nvPr>
              </p:nvGraphicFramePr>
              <p:xfrm>
                <a:off x="487599" y="1887997"/>
                <a:ext cx="3656013" cy="2587625"/>
              </p:xfrm>
              <a:graphic>
                <a:graphicData uri="http://schemas.openxmlformats.org/presentationml/2006/ole">
                  <p:oleObj spid="_x0000_s5950" name="Prism Project" r:id="rId6" imgW="3794760" imgH="2688120" progId="">
                    <p:embed/>
                  </p:oleObj>
                </a:graphicData>
              </a:graphic>
            </p:graphicFrame>
            <p:sp>
              <p:nvSpPr>
                <p:cNvPr id="30" name="TextBox 29"/>
                <p:cNvSpPr txBox="1"/>
                <p:nvPr/>
              </p:nvSpPr>
              <p:spPr>
                <a:xfrm>
                  <a:off x="3071992" y="2512586"/>
                  <a:ext cx="338554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2400" b="1" i="0" u="none" strike="noStrike" kern="0" cap="none" spc="0" normalizeH="0" baseline="0" noProof="0" dirty="0" smtClean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 panose="020F0502020204030204"/>
                      <a:ea typeface="+mn-ea"/>
                      <a:cs typeface="+mn-cs"/>
                    </a:rPr>
                    <a:t>*</a:t>
                  </a:r>
                  <a:endParaRPr kumimoji="0" lang="en-US" sz="24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endParaRPr>
                </a:p>
              </p:txBody>
            </p:sp>
          </p:grpSp>
          <p:sp>
            <p:nvSpPr>
              <p:cNvPr id="33" name="TextBox 32"/>
              <p:cNvSpPr txBox="1"/>
              <p:nvPr/>
            </p:nvSpPr>
            <p:spPr>
              <a:xfrm>
                <a:off x="6383619" y="5276112"/>
                <a:ext cx="272923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 8 </a:t>
                </a:r>
                <a:r>
                  <a:rPr kumimoji="0" lang="en-US" sz="1400" b="1" i="0" u="none" strike="noStrike" kern="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mos</a:t>
                </a:r>
                <a:r>
                  <a:rPr kumimoji="0" lang="en-US" sz="14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WT               8 </a:t>
                </a:r>
                <a:r>
                  <a:rPr kumimoji="0" lang="en-US" sz="1400" b="1" i="0" u="none" strike="noStrike" kern="0" cap="none" spc="0" normalizeH="0" baseline="0" noProof="0" dirty="0" err="1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mos</a:t>
                </a:r>
                <a:r>
                  <a:rPr kumimoji="0" lang="en-US" sz="14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3xTg</a:t>
                </a:r>
                <a:endParaRPr kumimoji="0" lang="en-US" sz="1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5546715" y="3096142"/>
                <a:ext cx="33054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800" b="1" i="0" u="none" strike="noStrike" kern="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D</a:t>
                </a:r>
              </a:p>
            </p:txBody>
          </p:sp>
        </p:grpSp>
        <p:sp>
          <p:nvSpPr>
            <p:cNvPr id="34" name="TextBox 33"/>
            <p:cNvSpPr txBox="1"/>
            <p:nvPr/>
          </p:nvSpPr>
          <p:spPr>
            <a:xfrm>
              <a:off x="6351592" y="633420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C</a:t>
              </a:r>
              <a:endParaRPr kumimoji="0" lang="en-US" sz="18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graphicFrame>
          <p:nvGraphicFramePr>
            <p:cNvPr id="36" name="Object 3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1394787361"/>
                </p:ext>
              </p:extLst>
            </p:nvPr>
          </p:nvGraphicFramePr>
          <p:xfrm>
            <a:off x="6219825" y="515938"/>
            <a:ext cx="3462338" cy="2506662"/>
          </p:xfrm>
          <a:graphic>
            <a:graphicData uri="http://schemas.openxmlformats.org/presentationml/2006/ole">
              <p:oleObj spid="_x0000_s5951" name="Prism Project" r:id="rId7" imgW="3672000" imgH="2664000" progId="">
                <p:embed/>
              </p:oleObj>
            </a:graphicData>
          </a:graphic>
        </p:graphicFrame>
      </p:grpSp>
      <p:sp>
        <p:nvSpPr>
          <p:cNvPr id="31" name="TextBox 30"/>
          <p:cNvSpPr txBox="1"/>
          <p:nvPr/>
        </p:nvSpPr>
        <p:spPr>
          <a:xfrm>
            <a:off x="2021989" y="5505317"/>
            <a:ext cx="835968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6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I.  </a:t>
            </a:r>
            <a:r>
              <a:rPr lang="en-US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-induced collateral rarefaction (Figure 1) 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as </a:t>
            </a:r>
            <a:r>
              <a:rPr lang="en-US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sociation with 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duced </a:t>
            </a:r>
            <a:r>
              <a:rPr lang="en-US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rain and body weight (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) and area </a:t>
            </a:r>
            <a:r>
              <a:rPr lang="en-US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the collateral zone between the MCA-ACA trees (B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.  </a:t>
            </a:r>
            <a:r>
              <a:rPr lang="en-US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stal-most arterioles (DMAs) of the MCA tree, that are nearby and of similar diameter as collaterals, evidenced no loss of number (C) or diameter (D).   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 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&lt;0.05 </a:t>
            </a:r>
            <a:r>
              <a:rPr lang="en-US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ersus 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. </a:t>
            </a:r>
            <a:endParaRPr lang="en-US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0713492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Box 31"/>
          <p:cNvSpPr txBox="1"/>
          <p:nvPr/>
        </p:nvSpPr>
        <p:spPr>
          <a:xfrm>
            <a:off x="706150" y="5337099"/>
            <a:ext cx="1097785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l figure </a:t>
            </a:r>
            <a:r>
              <a:rPr kumimoji="0" lang="en-US" sz="16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II.  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crofil-filled brain (top left panel) after </a:t>
            </a:r>
            <a:r>
              <a:rPr lang="en-US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ptical 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learing.  Top right panels, penetrating </a:t>
            </a: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rterioles (PAs, “perforators”, arrows identify several among those shown) branching from a pial collateral.  In contrast to collaterals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Figure 1</a:t>
            </a: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, AD did not induce loss of number or diameter of PAs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ranching </a:t>
            </a: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rom the extant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ollaterals </a:t>
            </a: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A,B) or</a:t>
            </a:r>
            <a:r>
              <a:rPr kumimoji="0" lang="en-US" sz="1600" b="0" i="0" u="none" strike="noStrike" kern="120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rom branches of the ACA tree (D</a:t>
            </a:r>
            <a:r>
              <a:rPr 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)</a:t>
            </a: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.  However, number of PAs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within the collateral zone tended to be lower </a:t>
            </a: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</a:t>
            </a: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, when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ormalized to </a:t>
            </a: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he collateral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zone </a:t>
            </a: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rea shown in Supplemental figure I, consistent with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he loss of </a:t>
            </a: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ollaterals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nd </a:t>
            </a: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ne</a:t>
            </a:r>
            <a:r>
              <a:rPr kumimoji="0" lang="en-US" sz="1600" b="0" i="0" u="none" strike="noStrike" kern="120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or more of </a:t>
            </a: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heir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ognate </a:t>
            </a: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As.  Each bar is from 8 mice.</a:t>
            </a:r>
            <a:endParaRPr kumimoji="0" 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339726" y="506410"/>
            <a:ext cx="11495087" cy="4775192"/>
            <a:chOff x="339726" y="506410"/>
            <a:chExt cx="11495087" cy="4775192"/>
          </a:xfrm>
        </p:grpSpPr>
        <p:grpSp>
          <p:nvGrpSpPr>
            <p:cNvPr id="8" name="Group 7"/>
            <p:cNvGrpSpPr/>
            <p:nvPr/>
          </p:nvGrpSpPr>
          <p:grpSpPr>
            <a:xfrm>
              <a:off x="5981700" y="2758726"/>
              <a:ext cx="2963863" cy="2284762"/>
              <a:chOff x="6246534" y="2540795"/>
              <a:chExt cx="3655015" cy="3054024"/>
            </a:xfrm>
          </p:grpSpPr>
          <p:graphicFrame>
            <p:nvGraphicFramePr>
              <p:cNvPr id="3" name="Object 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xmlns="" val="3569773148"/>
                  </p:ext>
                </p:extLst>
              </p:nvPr>
            </p:nvGraphicFramePr>
            <p:xfrm>
              <a:off x="6246534" y="2982637"/>
              <a:ext cx="3655015" cy="2612182"/>
            </p:xfrm>
            <a:graphic>
              <a:graphicData uri="http://schemas.openxmlformats.org/presentationml/2006/ole">
                <p:oleObj spid="_x0000_s6789" name="Prism Project" r:id="rId4" imgW="3636000" imgH="2736000" progId="">
                  <p:embed/>
                </p:oleObj>
              </a:graphicData>
            </a:graphic>
          </p:graphicFrame>
          <p:sp>
            <p:nvSpPr>
              <p:cNvPr id="11" name="TextBox 10"/>
              <p:cNvSpPr txBox="1"/>
              <p:nvPr/>
            </p:nvSpPr>
            <p:spPr>
              <a:xfrm>
                <a:off x="8583544" y="3618689"/>
                <a:ext cx="984480" cy="4464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p=0.057</a:t>
                </a:r>
                <a:endPara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6435948" y="2540795"/>
                <a:ext cx="320922" cy="4001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20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C</a:t>
                </a:r>
                <a:endParaRPr kumimoji="0" lang="en-US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339726" y="2834164"/>
              <a:ext cx="2905125" cy="2190272"/>
              <a:chOff x="6138732" y="4273256"/>
              <a:chExt cx="2882892" cy="2163014"/>
            </a:xfrm>
          </p:grpSpPr>
          <p:graphicFrame>
            <p:nvGraphicFramePr>
              <p:cNvPr id="16" name="Object 1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xmlns="" val="3387890759"/>
                  </p:ext>
                </p:extLst>
              </p:nvPr>
            </p:nvGraphicFramePr>
            <p:xfrm>
              <a:off x="6138732" y="4346468"/>
              <a:ext cx="2882892" cy="2089802"/>
            </p:xfrm>
            <a:graphic>
              <a:graphicData uri="http://schemas.openxmlformats.org/presentationml/2006/ole">
                <p:oleObj spid="_x0000_s6790" name="Prism Project" r:id="rId5" imgW="3672000" imgH="2664000" progId="">
                  <p:embed/>
                </p:oleObj>
              </a:graphicData>
            </a:graphic>
          </p:graphicFrame>
          <p:sp>
            <p:nvSpPr>
              <p:cNvPr id="17" name="TextBox 16"/>
              <p:cNvSpPr txBox="1"/>
              <p:nvPr/>
            </p:nvSpPr>
            <p:spPr>
              <a:xfrm>
                <a:off x="6324740" y="4273256"/>
                <a:ext cx="32412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8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A</a:t>
                </a:r>
                <a:endParaRPr kumimoji="0" lang="en-US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</p:grpSp>
        <p:grpSp>
          <p:nvGrpSpPr>
            <p:cNvPr id="10" name="Group 9"/>
            <p:cNvGrpSpPr/>
            <p:nvPr/>
          </p:nvGrpSpPr>
          <p:grpSpPr>
            <a:xfrm>
              <a:off x="4396056" y="507232"/>
              <a:ext cx="5748238" cy="2253895"/>
              <a:chOff x="1089469" y="554388"/>
              <a:chExt cx="5748238" cy="2253895"/>
            </a:xfrm>
          </p:grpSpPr>
          <p:pic>
            <p:nvPicPr>
              <p:cNvPr id="15" name="Picture 14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 xmlns="">
                      <a14:imgLayer r:embed="rId9">
                        <a14:imgEffect>
                          <a14:sharpenSoften amount="50000"/>
                        </a14:imgEffect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r="2277"/>
              <a:stretch/>
            </p:blipFill>
            <p:spPr>
              <a:xfrm>
                <a:off x="4020697" y="556872"/>
                <a:ext cx="2817010" cy="2251411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20" name="Picture 19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BEBA8EAE-BF5A-486C-A8C5-ECC9F3942E4B}">
                    <a14:imgProps xmlns:a14="http://schemas.microsoft.com/office/drawing/2010/main" xmlns="">
                      <a14:imgLayer r:embed="rId11">
                        <a14:imgEffect>
                          <a14:sharpenSoften amount="50000"/>
                        </a14:imgEffect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1116084" y="554388"/>
                <a:ext cx="2812946" cy="2247381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sp>
            <p:nvSpPr>
              <p:cNvPr id="21" name="TextBox 20"/>
              <p:cNvSpPr txBox="1"/>
              <p:nvPr/>
            </p:nvSpPr>
            <p:spPr>
              <a:xfrm>
                <a:off x="1089469" y="562651"/>
                <a:ext cx="965905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Dorsal  view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4048425" y="573580"/>
                <a:ext cx="793038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200" b="1" dirty="0" smtClean="0">
                    <a:solidFill>
                      <a:prstClr val="white"/>
                    </a:solidFill>
                    <a:latin typeface="Calibri"/>
                  </a:rPr>
                  <a:t>Side </a:t>
                </a:r>
                <a:r>
                  <a:rPr kumimoji="0" lang="en-US" sz="1200" b="1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Calibri"/>
                    <a:ea typeface="+mn-ea"/>
                    <a:cs typeface="+mn-cs"/>
                  </a:rPr>
                  <a:t>view</a:t>
                </a:r>
                <a:endPara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endParaRPr>
              </a:p>
            </p:txBody>
          </p:sp>
          <p:cxnSp>
            <p:nvCxnSpPr>
              <p:cNvPr id="23" name="Straight Arrow Connector 22"/>
              <p:cNvCxnSpPr/>
              <p:nvPr/>
            </p:nvCxnSpPr>
            <p:spPr>
              <a:xfrm>
                <a:off x="1810518" y="831223"/>
                <a:ext cx="205099" cy="85458"/>
              </a:xfrm>
              <a:prstGeom prst="straightConnector1">
                <a:avLst/>
              </a:prstGeom>
              <a:ln w="1905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Arrow Connector 23"/>
              <p:cNvCxnSpPr/>
              <p:nvPr/>
            </p:nvCxnSpPr>
            <p:spPr>
              <a:xfrm flipH="1">
                <a:off x="2681455" y="841480"/>
                <a:ext cx="137396" cy="193151"/>
              </a:xfrm>
              <a:prstGeom prst="straightConnector1">
                <a:avLst/>
              </a:prstGeom>
              <a:ln w="1905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Straight Arrow Connector 24"/>
              <p:cNvCxnSpPr/>
              <p:nvPr/>
            </p:nvCxnSpPr>
            <p:spPr>
              <a:xfrm flipH="1" flipV="1">
                <a:off x="5629709" y="2184744"/>
                <a:ext cx="188008" cy="145278"/>
              </a:xfrm>
              <a:prstGeom prst="straightConnector1">
                <a:avLst/>
              </a:prstGeom>
              <a:ln w="1905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aphicFrame>
          <p:nvGraphicFramePr>
            <p:cNvPr id="12" name="Object 1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1960017110"/>
                </p:ext>
              </p:extLst>
            </p:nvPr>
          </p:nvGraphicFramePr>
          <p:xfrm>
            <a:off x="3151188" y="2871788"/>
            <a:ext cx="2974975" cy="2149475"/>
          </p:xfrm>
          <a:graphic>
            <a:graphicData uri="http://schemas.openxmlformats.org/presentationml/2006/ole">
              <p:oleObj spid="_x0000_s6791" name="Prism Project" r:id="rId12" imgW="3708000" imgH="2664000" progId="">
                <p:embed/>
              </p:oleObj>
            </a:graphicData>
          </a:graphic>
        </p:graphicFrame>
        <p:sp>
          <p:nvSpPr>
            <p:cNvPr id="28" name="TextBox 27"/>
            <p:cNvSpPr txBox="1"/>
            <p:nvPr/>
          </p:nvSpPr>
          <p:spPr>
            <a:xfrm>
              <a:off x="3403630" y="4943048"/>
              <a:ext cx="715053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</a:t>
              </a:r>
              <a:r>
                <a:rPr kumimoji="0" lang="en-US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White</a:t>
              </a:r>
              <a:r>
                <a:rPr kumimoji="0" lang="en-US" sz="1600" b="1" i="0" u="none" strike="noStrike" kern="1200" cap="none" spc="0" normalizeH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bars, </a:t>
              </a:r>
              <a:r>
                <a:rPr kumimoji="0" lang="en-US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8 months-old WT.</a:t>
              </a:r>
              <a:r>
                <a:rPr kumimoji="0" lang="en-US" sz="1600" b="1" i="0" u="none" strike="noStrike" kern="1200" cap="none" spc="0" normalizeH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    Black bars,</a:t>
              </a:r>
              <a:r>
                <a:rPr kumimoji="0" lang="en-US" sz="16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8 months-old 3xTg.</a:t>
              </a:r>
              <a:endPara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164808" y="2765986"/>
              <a:ext cx="301494" cy="3697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B</a:t>
              </a:r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 xmlns="">
                    <a14:imgLayer r:embed="rId15">
                      <a14:imgEffect>
                        <a14:sharpenSoften amount="500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 t="9772"/>
            <a:stretch/>
          </p:blipFill>
          <p:spPr>
            <a:xfrm>
              <a:off x="2170601" y="506410"/>
              <a:ext cx="2160403" cy="2252116"/>
            </a:xfrm>
            <a:prstGeom prst="rect">
              <a:avLst/>
            </a:prstGeom>
          </p:spPr>
        </p:pic>
        <p:graphicFrame>
          <p:nvGraphicFramePr>
            <p:cNvPr id="26" name="Object 2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2403091693"/>
                </p:ext>
              </p:extLst>
            </p:nvPr>
          </p:nvGraphicFramePr>
          <p:xfrm>
            <a:off x="8810625" y="2871788"/>
            <a:ext cx="3024188" cy="2147887"/>
          </p:xfrm>
          <a:graphic>
            <a:graphicData uri="http://schemas.openxmlformats.org/presentationml/2006/ole">
              <p:oleObj spid="_x0000_s6792" name="Prism Project" r:id="rId16" imgW="3744000" imgH="2664000" progId="">
                <p:embed/>
              </p:oleObj>
            </a:graphicData>
          </a:graphic>
        </p:graphicFrame>
        <p:sp>
          <p:nvSpPr>
            <p:cNvPr id="27" name="TextBox 26"/>
            <p:cNvSpPr txBox="1"/>
            <p:nvPr/>
          </p:nvSpPr>
          <p:spPr>
            <a:xfrm>
              <a:off x="8858472" y="2771438"/>
              <a:ext cx="34657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2000" b="1" dirty="0">
                  <a:solidFill>
                    <a:prstClr val="black"/>
                  </a:solidFill>
                  <a:latin typeface="Calibri"/>
                </a:rPr>
                <a:t>D</a:t>
              </a:r>
              <a:endPara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xmlns="" val="6920380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3827936" y="3957956"/>
          <a:ext cx="6358002" cy="1402683"/>
        </p:xfrm>
        <a:graphic>
          <a:graphicData uri="http://schemas.openxmlformats.org/drawingml/2006/table">
            <a:tbl>
              <a:tblPr firstRow="1" lastRow="1">
                <a:tableStyleId>{3C2FFA5D-87B4-456A-9821-1D502468CF0F}</a:tableStyleId>
              </a:tblPr>
              <a:tblGrid>
                <a:gridCol w="63181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603533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7265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35662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27815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808976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623044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572914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314270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640935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726392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</a:tblGrid>
              <a:tr h="275326"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</a:t>
                      </a:r>
                      <a:r>
                        <a:rPr lang="en-US" sz="1600" b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-age</a:t>
                      </a:r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 </a:t>
                      </a:r>
                      <a:r>
                        <a:rPr lang="en-US" sz="1600" b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-age</a:t>
                      </a:r>
                      <a:endParaRPr lang="en-US" sz="16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75326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xTg-AD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400" b="1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xTg-AD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52211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 zon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A zon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 zone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A zon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 zon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A zon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 zone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A </a:t>
                      </a:r>
                      <a:endParaRPr lang="en-US" sz="1200" b="0" u="none" strike="noStrike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en-US" sz="1200" b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on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29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+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-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b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b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en-US" sz="1400" b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+++</a:t>
                      </a:r>
                      <a:endParaRPr lang="en-US" sz="1400" b="0" u="none" strike="noStrike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+++</a:t>
                      </a:r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827893" y="4304393"/>
            <a:ext cx="184481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O-1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xpression </a:t>
            </a:r>
            <a:r>
              <a:rPr kumimoji="0" lang="en-US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n 3xTg-AD mice 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549400" y="139220"/>
            <a:ext cx="9056809" cy="3652490"/>
            <a:chOff x="1549400" y="661412"/>
            <a:chExt cx="9056809" cy="3652490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 xmlns="">
                    <a14:imgLayer r:embed="rId4">
                      <a14:imgEffect>
                        <a14:sharpenSoften amount="5000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19527"/>
            <a:stretch/>
          </p:blipFill>
          <p:spPr>
            <a:xfrm>
              <a:off x="1593435" y="2528133"/>
              <a:ext cx="2219091" cy="1785769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 xmlns="">
                    <a14:imgLayer r:embed="rId6">
                      <a14:imgEffect>
                        <a14:sharpenSoften amount="50000"/>
                      </a14:imgEffect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19225"/>
            <a:stretch/>
          </p:blipFill>
          <p:spPr>
            <a:xfrm>
              <a:off x="8379145" y="2514317"/>
              <a:ext cx="2219091" cy="1792470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 xmlns="">
                    <a14:imgLayer r:embed="rId8">
                      <a14:imgEffect>
                        <a14:sharpenSoften amount="50000"/>
                      </a14:imgEffect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19918"/>
            <a:stretch/>
          </p:blipFill>
          <p:spPr>
            <a:xfrm>
              <a:off x="3856313" y="2529685"/>
              <a:ext cx="2219091" cy="1777102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 xmlns="">
                    <a14:imgLayer r:embed="rId10">
                      <a14:imgEffect>
                        <a14:sharpenSoften amount="5000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19571"/>
            <a:stretch/>
          </p:blipFill>
          <p:spPr>
            <a:xfrm>
              <a:off x="6111139" y="2522001"/>
              <a:ext cx="2219090" cy="1784784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 xmlns="">
                    <a14:imgLayer r:embed="rId12">
                      <a14:imgEffect>
                        <a14:sharpenSoften amount="50000"/>
                      </a14:imgEffect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19858"/>
            <a:stretch/>
          </p:blipFill>
          <p:spPr>
            <a:xfrm>
              <a:off x="3856312" y="707726"/>
              <a:ext cx="2219098" cy="1778441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 xmlns="">
                    <a14:imgLayer r:embed="rId14">
                      <a14:imgEffect>
                        <a14:sharpenSoften amount="50000"/>
                      </a14:imgEffect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19858"/>
            <a:stretch/>
          </p:blipFill>
          <p:spPr>
            <a:xfrm>
              <a:off x="1590910" y="707727"/>
              <a:ext cx="2219091" cy="1778435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BEBA8EAE-BF5A-486C-A8C5-ECC9F3942E4B}">
                  <a14:imgProps xmlns:a14="http://schemas.microsoft.com/office/drawing/2010/main" xmlns="">
                    <a14:imgLayer r:embed="rId16">
                      <a14:imgEffect>
                        <a14:sharpenSoften amount="50000"/>
                      </a14:imgEffect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19165"/>
            <a:stretch/>
          </p:blipFill>
          <p:spPr>
            <a:xfrm>
              <a:off x="8387119" y="692359"/>
              <a:ext cx="2219090" cy="1793802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BEBA8EAE-BF5A-486C-A8C5-ECC9F3942E4B}">
                  <a14:imgProps xmlns:a14="http://schemas.microsoft.com/office/drawing/2010/main" xmlns="">
                    <a14:imgLayer r:embed="rId18">
                      <a14:imgEffect>
                        <a14:sharpenSoften amount="50000"/>
                      </a14:imgEffect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19511"/>
            <a:stretch/>
          </p:blipFill>
          <p:spPr>
            <a:xfrm>
              <a:off x="6121709" y="700043"/>
              <a:ext cx="2219090" cy="1786118"/>
            </a:xfrm>
            <a:prstGeom prst="rect">
              <a:avLst/>
            </a:prstGeom>
          </p:spPr>
        </p:pic>
        <p:sp>
          <p:nvSpPr>
            <p:cNvPr id="19" name="TextBox 18"/>
            <p:cNvSpPr txBox="1"/>
            <p:nvPr/>
          </p:nvSpPr>
          <p:spPr>
            <a:xfrm>
              <a:off x="1549400" y="669884"/>
              <a:ext cx="1390359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WT-8 </a:t>
              </a:r>
              <a:r>
                <a:rPr kumimoji="0" lang="en-US" sz="14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mos</a:t>
              </a: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COL zone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HO-1</a:t>
              </a:r>
              <a:endParaRPr kumimoji="0" lang="en-US" sz="1400" b="0" i="0" u="none" strike="noStrike" kern="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818477" y="678350"/>
              <a:ext cx="139035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WT-8 </a:t>
              </a:r>
              <a:r>
                <a:rPr kumimoji="0" lang="en-US" sz="14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mos</a:t>
              </a: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DMA zone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070618" y="669882"/>
              <a:ext cx="139035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WT-18 </a:t>
              </a:r>
              <a:r>
                <a:rPr kumimoji="0" lang="en-US" sz="14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mos</a:t>
              </a: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COL zone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8348159" y="661412"/>
              <a:ext cx="139035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WT-18 </a:t>
              </a:r>
              <a:r>
                <a:rPr kumimoji="0" lang="en-US" sz="14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mos</a:t>
              </a: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DMA zone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818480" y="2490217"/>
              <a:ext cx="139035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3xTg-8 </a:t>
              </a:r>
              <a:r>
                <a:rPr kumimoji="0" lang="en-US" sz="14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mos</a:t>
              </a: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DMA zone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6079089" y="2490215"/>
              <a:ext cx="139035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3xTg-18 </a:t>
              </a:r>
              <a:r>
                <a:rPr kumimoji="0" lang="en-US" sz="14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mos</a:t>
              </a: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COL zone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8348160" y="2490215"/>
              <a:ext cx="139035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3xTg-18 </a:t>
              </a:r>
              <a:r>
                <a:rPr kumimoji="0" lang="en-US" sz="1400" b="0" i="0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mos</a:t>
              </a: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0" u="none" strike="noStrike" kern="0" cap="none" spc="0" normalizeH="0" baseline="0" noProof="0" dirty="0" smtClean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DMA zone</a:t>
              </a:r>
            </a:p>
          </p:txBody>
        </p:sp>
      </p:grpSp>
      <p:sp>
        <p:nvSpPr>
          <p:cNvPr id="30" name="TextBox 29"/>
          <p:cNvSpPr txBox="1"/>
          <p:nvPr/>
        </p:nvSpPr>
        <p:spPr>
          <a:xfrm>
            <a:off x="1214082" y="5470752"/>
            <a:ext cx="9989628" cy="1246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kumimoji="0" lang="en-US" sz="15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Supplemental figure IV.  </a:t>
            </a:r>
            <a:r>
              <a:rPr kumimoji="0" lang="en-US" sz="15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Collateral </a:t>
            </a:r>
            <a:r>
              <a:rPr kumimoji="0" lang="en-US" sz="15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arefaction coincides with presence of intracerebral </a:t>
            </a:r>
            <a:r>
              <a:rPr kumimoji="0" lang="en-US" sz="15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HO-1 expression.  </a:t>
            </a:r>
            <a:r>
              <a:rPr kumimoji="0" lang="en-US" sz="15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resentative sections </a:t>
            </a:r>
            <a:r>
              <a:rPr kumimoji="0" lang="en-US" sz="15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f neocortex underlying </a:t>
            </a:r>
            <a:r>
              <a:rPr kumimoji="0" lang="en-US" sz="15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he collateral </a:t>
            </a:r>
            <a:r>
              <a:rPr kumimoji="0" lang="en-US" sz="15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COL</a:t>
            </a:r>
            <a:r>
              <a:rPr kumimoji="0" lang="en-US" sz="15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) zone between MCA and ACA trees and the distal-most arteriole (DMA) </a:t>
            </a:r>
            <a:r>
              <a:rPr kumimoji="0" lang="en-US" sz="15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zone of </a:t>
            </a:r>
            <a:r>
              <a:rPr kumimoji="0" lang="en-US" sz="15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he ACA tree of WT </a:t>
            </a:r>
            <a:r>
              <a:rPr kumimoji="0" lang="en-US" sz="15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nd 3xTg-AD </a:t>
            </a:r>
            <a:r>
              <a:rPr kumimoji="0" lang="en-US" sz="15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ice. </a:t>
            </a:r>
            <a:r>
              <a:rPr lang="en-US" sz="15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gnification bars, 50</a:t>
            </a:r>
            <a:r>
              <a:rPr lang="en-US" sz="15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sz="15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. Table</a:t>
            </a:r>
            <a:r>
              <a:rPr kumimoji="0" lang="en-US" sz="15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, </a:t>
            </a:r>
            <a:r>
              <a:rPr kumimoji="0" lang="en-US" sz="15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HO-1 </a:t>
            </a:r>
            <a:r>
              <a:rPr kumimoji="0" lang="en-US" sz="15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n AD mice increased between 8 and 18 </a:t>
            </a:r>
            <a:r>
              <a:rPr kumimoji="0" lang="en-US" sz="15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onths-age and became detectable in WT mice at 18 months-age; </a:t>
            </a:r>
            <a:r>
              <a:rPr kumimoji="0" lang="en-US" sz="15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core </a:t>
            </a:r>
            <a:r>
              <a:rPr kumimoji="0" lang="en-US" sz="15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was slightly lower underlying </a:t>
            </a:r>
            <a:r>
              <a:rPr kumimoji="0" lang="en-US" sz="15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he collateral </a:t>
            </a:r>
            <a:r>
              <a:rPr kumimoji="0" lang="en-US" sz="15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zone.  </a:t>
            </a:r>
            <a:r>
              <a:rPr kumimoji="0" lang="en-US" sz="15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 = </a:t>
            </a:r>
            <a:r>
              <a:rPr kumimoji="0" lang="en-US" sz="15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5 </a:t>
            </a:r>
            <a:r>
              <a:rPr kumimoji="0" lang="en-US" sz="15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or 8 and 18 months-old WT and 3xTg </a:t>
            </a:r>
            <a:r>
              <a:rPr kumimoji="0" lang="en-US" sz="15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ice. Images </a:t>
            </a:r>
            <a:r>
              <a:rPr kumimoji="0" lang="en-US" sz="15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cored blindly by two independent observers.</a:t>
            </a:r>
            <a:endParaRPr kumimoji="0" lang="en-US" sz="15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550954" y="1963409"/>
            <a:ext cx="139035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3xTg-8 </a:t>
            </a:r>
            <a:r>
              <a:rPr kumimoji="0" lang="en-US" sz="14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os</a:t>
            </a:r>
            <a:r>
              <a:rPr kumimoji="0" lang="en-US" sz="1400" b="0" i="0" u="none" strike="noStrike" kern="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400" kern="0" dirty="0" smtClean="0">
                <a:solidFill>
                  <a:prstClr val="white"/>
                </a:solidFill>
                <a:latin typeface="Calibri"/>
              </a:rPr>
              <a:t>COL </a:t>
            </a:r>
            <a:r>
              <a:rPr kumimoji="0" lang="en-US" sz="1400" b="0" i="0" u="none" strike="noStrike" kern="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zone</a:t>
            </a:r>
          </a:p>
        </p:txBody>
      </p:sp>
    </p:spTree>
    <p:extLst>
      <p:ext uri="{BB962C8B-B14F-4D97-AF65-F5344CB8AC3E}">
        <p14:creationId xmlns:p14="http://schemas.microsoft.com/office/powerpoint/2010/main" xmlns="" val="34580553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69</TotalTime>
  <Words>678</Words>
  <Application>Microsoft Office PowerPoint</Application>
  <PresentationFormat>Custom</PresentationFormat>
  <Paragraphs>74</Paragraphs>
  <Slides>4</Slides>
  <Notes>3</Notes>
  <HiddenSlides>0</HiddenSlides>
  <MMClips>0</MMClips>
  <ScaleCrop>false</ScaleCrop>
  <HeadingPairs>
    <vt:vector size="6" baseType="variant">
      <vt:variant>
        <vt:lpstr>Theme</vt:lpstr>
      </vt:variant>
      <vt:variant>
        <vt:i4>2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Office Theme</vt:lpstr>
      <vt:lpstr>1_Office Theme</vt:lpstr>
      <vt:lpstr>Prism Project</vt:lpstr>
      <vt:lpstr>Slide 1</vt:lpstr>
      <vt:lpstr>Slide 2</vt:lpstr>
      <vt:lpstr>Slide 3</vt:lpstr>
      <vt:lpstr>Slide 4</vt:lpstr>
    </vt:vector>
  </TitlesOfParts>
  <Company>UNC Chapel Hill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ber, James E</dc:creator>
  <cp:lastModifiedBy>0014780</cp:lastModifiedBy>
  <cp:revision>239</cp:revision>
  <cp:lastPrinted>2018-10-23T18:24:14Z</cp:lastPrinted>
  <dcterms:created xsi:type="dcterms:W3CDTF">2018-05-03T15:28:35Z</dcterms:created>
  <dcterms:modified xsi:type="dcterms:W3CDTF">2018-11-21T04:36:47Z</dcterms:modified>
</cp:coreProperties>
</file>